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64" r:id="rId3"/>
    <p:sldId id="277" r:id="rId4"/>
    <p:sldId id="278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173" autoAdjust="0"/>
    <p:restoredTop sz="94660"/>
  </p:normalViewPr>
  <p:slideViewPr>
    <p:cSldViewPr snapToGrid="0">
      <p:cViewPr varScale="1">
        <p:scale>
          <a:sx n="65" d="100"/>
          <a:sy n="65" d="100"/>
        </p:scale>
        <p:origin x="72" y="10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C0E6DAA-87D2-41D5-F844-493F59CFF4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A9D4763-96E3-913F-022F-A37CA16A1C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BCB504B-2114-802C-04A2-71056B300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180E41D-47D7-1FF3-2346-557EEA82D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36B63DB-09CC-0AD1-C703-435FA2146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5535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EED2C0-2003-31D5-BD8B-D2DC990853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D094113-757C-392B-220C-4414EDF89C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454724F-836E-8A73-C260-2B9989599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48E1F6B-697D-A657-DA24-2B3E569DB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C6DD5BA-3C2A-F307-C3C5-00623C250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5013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686F7763-2FFC-070D-DA24-08EF111485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6F2A037-60BB-B0E6-3010-0CD678DBAE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1C9F31-0BD4-22E7-6CD6-3DB9438B7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6425F41-70F1-FC2C-7793-A3477F6F2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5BDB157-32CB-F813-2A51-FEF1881C0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287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8BDB49-0B77-356C-F8B3-81F7DE75F9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41AC942-E80F-04ED-DAF7-4829D88F74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BF9565-C1B5-E8AA-BEEE-9011A1D8E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CCDC135-893B-8A10-D0E9-E52227B99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2025D6A-5961-40C8-6939-418340DE69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181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FFFF730-5C1F-55FD-E00C-CBC8D3D1F8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0291A6C-EA6D-214A-1064-491B3180FA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2EF12EA-6681-8BF6-CF54-D4327AE60A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BD25F37-0A80-5370-9FD2-DD399EFAED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790502C-F219-6DB5-B2E0-44442514B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6627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391D384-A5A2-0940-834C-6A4F03A281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FEAD44C-FED3-57B3-5318-262D3A16F8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AB88875-D48A-5CC1-C83F-F141DED9D2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48E9140-A148-A611-624C-4A9F0F4D2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804897A-9773-E519-4E40-5AB4519F6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77CA776-AC5B-45BB-32C8-CDD3C1510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4472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0C9D57-8C3C-B073-C0D0-E0E98753E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4328C15-DF56-E171-ED81-E4A448A330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EB8B06B-3A78-0D6B-490F-D9C83A46B9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141EBF8-8287-A89D-2A2E-C936400CCD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7E1D13F-FF01-E285-A1B0-D61C979E92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FBFA957-A2AE-887F-037A-88C54BD3D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A8030C5-4239-BC37-1C6D-858C1A901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65902278-64A3-DD70-474A-CEA041FE8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3128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1E59439-E8ED-A532-4BDE-DEE8CA1DE1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677E90E-8227-2C8F-A7E4-60A630A14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4580E5B-C775-EC04-30A7-9F1125B333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19DF7E1-1CE6-7EAE-D0D4-DDBF083CE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5191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1EEAFC6F-BC71-2795-86FD-670BD50A4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2846A08-6424-9835-762D-3A98617D3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7F1D113-CB6D-0B34-365F-A50E1B394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6071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7BE9AD7-9148-B057-04D8-85B970375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88D16F7-8F60-1849-3F89-D0C4E8B9C6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6314396-59ED-D2B2-950D-2A702A226D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4026205-BECC-8021-CE6C-D7F4255FB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6BB9F5D-4943-562E-6DC1-19B279AE8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2BF4547-8899-A332-E127-873E7CDDA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6838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ED7C76C-CF53-7DA8-0004-EEF1355FD4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8250531-B181-CC17-BB94-0FEC0EFB9C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C09C165-3762-F0E4-F036-F89407F2A3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3AB6DFA-6204-705D-E545-5E813814B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76B0FC2-DD4B-CB95-9809-0E5B48D3F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E698814-E703-DF39-87F2-2F48AA72B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7266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13477899-5616-165F-C5ED-81EAA11EBE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4CBE4D4-78F5-35F5-C2F0-6B67075B85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66A5AF4-02F4-DEBF-E6D2-9F6EBA2908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305308-63A4-4D54-AB13-FC9A6D291E3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57B281A-B289-079D-3F43-2FEA371924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2102421-F638-EECF-33B9-0896ED0066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28E3EBF-389A-4B63-8877-152EA31E8E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8499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1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2" Type="http://schemas.openxmlformats.org/officeDocument/2006/relationships/image" Target="../media/image1.png"/><Relationship Id="rId16" Type="http://schemas.microsoft.com/office/2007/relationships/hdphoto" Target="../media/hdphoto3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microsoft.com/office/2007/relationships/hdphoto" Target="../media/hdphoto1.wdp"/><Relationship Id="rId5" Type="http://schemas.openxmlformats.org/officeDocument/2006/relationships/image" Target="../media/image4.png"/><Relationship Id="rId15" Type="http://schemas.openxmlformats.org/officeDocument/2006/relationships/image" Target="../media/image12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microsoft.com/office/2007/relationships/hdphoto" Target="../media/hdphoto2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그룹 65">
            <a:extLst>
              <a:ext uri="{FF2B5EF4-FFF2-40B4-BE49-F238E27FC236}">
                <a16:creationId xmlns:a16="http://schemas.microsoft.com/office/drawing/2014/main" id="{FB47DB69-8238-3FCB-D0AD-D61CAD7343C2}"/>
              </a:ext>
            </a:extLst>
          </p:cNvPr>
          <p:cNvGrpSpPr/>
          <p:nvPr/>
        </p:nvGrpSpPr>
        <p:grpSpPr>
          <a:xfrm>
            <a:off x="1279036" y="1481198"/>
            <a:ext cx="9544533" cy="3881139"/>
            <a:chOff x="1279036" y="1481198"/>
            <a:chExt cx="9544533" cy="3881139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54D29ED7-BE20-11D0-919E-47FC1F1FB5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08434" y="1788975"/>
              <a:ext cx="1440000" cy="1440000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C1B6410E-6755-6928-FC74-F4C0E68EF80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39859" y="1788975"/>
              <a:ext cx="1440000" cy="1440000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3753C6A0-C5EB-BB74-323B-ADE8620AF2B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39859" y="3538537"/>
              <a:ext cx="1440000" cy="1440000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56AF58CF-3D15-30AC-E7E8-D3A52481E5D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808434" y="3532050"/>
              <a:ext cx="1440000" cy="14400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F72C3F8-342B-4B11-0198-BAD42A28A444}"/>
                </a:ext>
              </a:extLst>
            </p:cNvPr>
            <p:cNvSpPr txBox="1"/>
            <p:nvPr/>
          </p:nvSpPr>
          <p:spPr>
            <a:xfrm>
              <a:off x="1279036" y="1481198"/>
              <a:ext cx="15616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DC16EDC-B70A-6931-AC9F-C7A87C24AA67}"/>
                </a:ext>
              </a:extLst>
            </p:cNvPr>
            <p:cNvSpPr txBox="1"/>
            <p:nvPr/>
          </p:nvSpPr>
          <p:spPr>
            <a:xfrm>
              <a:off x="2808433" y="1481198"/>
              <a:ext cx="14399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256797F-3FA5-4174-C3F3-12AB3AF75989}"/>
                </a:ext>
              </a:extLst>
            </p:cNvPr>
            <p:cNvSpPr txBox="1"/>
            <p:nvPr/>
          </p:nvSpPr>
          <p:spPr>
            <a:xfrm>
              <a:off x="1339859" y="3228975"/>
              <a:ext cx="14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fa2-EGFP</a:t>
              </a:r>
              <a:endPara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CAE14AF-FDCE-54D5-CB20-A27B7B068353}"/>
                </a:ext>
              </a:extLst>
            </p:cNvPr>
            <p:cNvSpPr txBox="1"/>
            <p:nvPr/>
          </p:nvSpPr>
          <p:spPr>
            <a:xfrm>
              <a:off x="2808432" y="3228975"/>
              <a:ext cx="14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B RFP</a:t>
              </a:r>
              <a:endPara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직선 연결선 15">
              <a:extLst>
                <a:ext uri="{FF2B5EF4-FFF2-40B4-BE49-F238E27FC236}">
                  <a16:creationId xmlns:a16="http://schemas.microsoft.com/office/drawing/2014/main" id="{8D581134-16EB-0D78-A14B-14766C98C423}"/>
                </a:ext>
              </a:extLst>
            </p:cNvPr>
            <p:cNvCxnSpPr/>
            <p:nvPr/>
          </p:nvCxnSpPr>
          <p:spPr>
            <a:xfrm>
              <a:off x="1427170" y="3140364"/>
              <a:ext cx="2952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98BE375-FDC2-A0AE-E4D6-8C61A40D9705}"/>
                </a:ext>
              </a:extLst>
            </p:cNvPr>
            <p:cNvSpPr txBox="1"/>
            <p:nvPr/>
          </p:nvSpPr>
          <p:spPr>
            <a:xfrm>
              <a:off x="1339858" y="5054560"/>
              <a:ext cx="2908573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B0C4AFD9-9B60-3E07-A4EE-7B7F44D2900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093812" y="1788975"/>
              <a:ext cx="1442188" cy="1440000"/>
            </a:xfrm>
            <a:prstGeom prst="rect">
              <a:avLst/>
            </a:prstGeom>
          </p:spPr>
        </p:pic>
        <p:pic>
          <p:nvPicPr>
            <p:cNvPr id="21" name="그림 20">
              <a:extLst>
                <a:ext uri="{FF2B5EF4-FFF2-40B4-BE49-F238E27FC236}">
                  <a16:creationId xmlns:a16="http://schemas.microsoft.com/office/drawing/2014/main" id="{EB33DD50-1E2C-07FB-73BD-05E053F6BB6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625237" y="1788975"/>
              <a:ext cx="1440000" cy="1440000"/>
            </a:xfrm>
            <a:prstGeom prst="rect">
              <a:avLst/>
            </a:prstGeom>
          </p:spPr>
        </p:pic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B27DB786-1E89-7ABC-770A-E37449AB6F7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625237" y="3532049"/>
              <a:ext cx="1440000" cy="1446487"/>
            </a:xfrm>
            <a:prstGeom prst="rect">
              <a:avLst/>
            </a:prstGeom>
          </p:spPr>
        </p:pic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A0BEA1CD-F732-5C08-B164-5DCA410A5C3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096000" y="3538537"/>
              <a:ext cx="1440000" cy="1440000"/>
            </a:xfrm>
            <a:prstGeom prst="rect">
              <a:avLst/>
            </a:prstGeom>
          </p:spPr>
        </p:pic>
        <p:pic>
          <p:nvPicPr>
            <p:cNvPr id="27" name="그림 26">
              <a:extLst>
                <a:ext uri="{FF2B5EF4-FFF2-40B4-BE49-F238E27FC236}">
                  <a16:creationId xmlns:a16="http://schemas.microsoft.com/office/drawing/2014/main" id="{474ADA43-FA2B-7C41-DD5F-E8EFD9EDA1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381378" y="1788975"/>
              <a:ext cx="1440000" cy="1440000"/>
            </a:xfrm>
            <a:prstGeom prst="rect">
              <a:avLst/>
            </a:prstGeom>
          </p:spPr>
        </p:pic>
        <p:pic>
          <p:nvPicPr>
            <p:cNvPr id="29" name="그림 28">
              <a:extLst>
                <a:ext uri="{FF2B5EF4-FFF2-40B4-BE49-F238E27FC236}">
                  <a16:creationId xmlns:a16="http://schemas.microsoft.com/office/drawing/2014/main" id="{036C447B-810D-B5E5-FAC2-CE9ECBEC2633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9381378" y="3538537"/>
              <a:ext cx="1440000" cy="1440000"/>
            </a:xfrm>
            <a:prstGeom prst="rect">
              <a:avLst/>
            </a:prstGeom>
          </p:spPr>
        </p:pic>
        <p:pic>
          <p:nvPicPr>
            <p:cNvPr id="31" name="그림 30">
              <a:extLst>
                <a:ext uri="{FF2B5EF4-FFF2-40B4-BE49-F238E27FC236}">
                  <a16:creationId xmlns:a16="http://schemas.microsoft.com/office/drawing/2014/main" id="{43939A03-7DF6-4508-F3E4-0DED9783CA4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912803" y="3532050"/>
              <a:ext cx="1440000" cy="1440000"/>
            </a:xfrm>
            <a:prstGeom prst="rect">
              <a:avLst/>
            </a:prstGeom>
          </p:spPr>
        </p:pic>
        <p:pic>
          <p:nvPicPr>
            <p:cNvPr id="33" name="그림 32">
              <a:extLst>
                <a:ext uri="{FF2B5EF4-FFF2-40B4-BE49-F238E27FC236}">
                  <a16:creationId xmlns:a16="http://schemas.microsoft.com/office/drawing/2014/main" id="{FF5B8E97-3CBA-DBCB-649F-FAD6B09F7092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912803" y="1788975"/>
              <a:ext cx="1440000" cy="1440000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9178454-4097-4A71-9564-7517D1422B64}"/>
                </a:ext>
              </a:extLst>
            </p:cNvPr>
            <p:cNvSpPr txBox="1"/>
            <p:nvPr/>
          </p:nvSpPr>
          <p:spPr>
            <a:xfrm>
              <a:off x="4653812" y="5054559"/>
              <a:ext cx="2882188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18 </a:t>
              </a:r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endPara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3FC3F08-CAE1-8F5D-2150-CC70B4DBEA23}"/>
                </a:ext>
              </a:extLst>
            </p:cNvPr>
            <p:cNvSpPr txBox="1"/>
            <p:nvPr/>
          </p:nvSpPr>
          <p:spPr>
            <a:xfrm>
              <a:off x="7941381" y="5054559"/>
              <a:ext cx="2882188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ouble KD</a:t>
              </a:r>
              <a:endPara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A133F7C-13D8-2401-C3C2-705D150D878B}"/>
                </a:ext>
              </a:extLst>
            </p:cNvPr>
            <p:cNvSpPr txBox="1"/>
            <p:nvPr/>
          </p:nvSpPr>
          <p:spPr>
            <a:xfrm>
              <a:off x="4629970" y="1495664"/>
              <a:ext cx="15616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89AB836-3B49-A1C4-038E-5882A1B92B38}"/>
                </a:ext>
              </a:extLst>
            </p:cNvPr>
            <p:cNvSpPr txBox="1"/>
            <p:nvPr/>
          </p:nvSpPr>
          <p:spPr>
            <a:xfrm>
              <a:off x="6159367" y="1495664"/>
              <a:ext cx="14399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775C97D-C100-5DEA-3DC0-E3181F515399}"/>
                </a:ext>
              </a:extLst>
            </p:cNvPr>
            <p:cNvSpPr txBox="1"/>
            <p:nvPr/>
          </p:nvSpPr>
          <p:spPr>
            <a:xfrm>
              <a:off x="7823406" y="1485900"/>
              <a:ext cx="15616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EEAA7B3-18F8-31B4-752C-D7185D49523C}"/>
                </a:ext>
              </a:extLst>
            </p:cNvPr>
            <p:cNvSpPr txBox="1"/>
            <p:nvPr/>
          </p:nvSpPr>
          <p:spPr>
            <a:xfrm>
              <a:off x="9352803" y="1485900"/>
              <a:ext cx="14399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AC8D2FE-9375-7920-A847-2F11A229DFDD}"/>
                </a:ext>
              </a:extLst>
            </p:cNvPr>
            <p:cNvSpPr txBox="1"/>
            <p:nvPr/>
          </p:nvSpPr>
          <p:spPr>
            <a:xfrm>
              <a:off x="4619000" y="3229005"/>
              <a:ext cx="14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fa2-EGFP</a:t>
              </a:r>
              <a:endPara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31051D6-A2A0-DE24-AD0A-4A5026C039DC}"/>
                </a:ext>
              </a:extLst>
            </p:cNvPr>
            <p:cNvSpPr txBox="1"/>
            <p:nvPr/>
          </p:nvSpPr>
          <p:spPr>
            <a:xfrm>
              <a:off x="6087573" y="3229005"/>
              <a:ext cx="14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B RFP</a:t>
              </a:r>
              <a:endPara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5A20D21-4C90-4B26-DF8E-6383AA795343}"/>
                </a:ext>
              </a:extLst>
            </p:cNvPr>
            <p:cNvSpPr txBox="1"/>
            <p:nvPr/>
          </p:nvSpPr>
          <p:spPr>
            <a:xfrm>
              <a:off x="7910615" y="3217218"/>
              <a:ext cx="14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fa2-EGFP</a:t>
              </a:r>
              <a:endPara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F616A47-193D-FA64-AACA-7EFD78B47AAE}"/>
                </a:ext>
              </a:extLst>
            </p:cNvPr>
            <p:cNvSpPr txBox="1"/>
            <p:nvPr/>
          </p:nvSpPr>
          <p:spPr>
            <a:xfrm>
              <a:off x="9379188" y="3217218"/>
              <a:ext cx="144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B RFP</a:t>
              </a:r>
              <a:endPara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이등변 삼각형 44">
              <a:extLst>
                <a:ext uri="{FF2B5EF4-FFF2-40B4-BE49-F238E27FC236}">
                  <a16:creationId xmlns:a16="http://schemas.microsoft.com/office/drawing/2014/main" id="{1CE6D857-3FBA-DACE-3153-4FC19D57AA2E}"/>
                </a:ext>
              </a:extLst>
            </p:cNvPr>
            <p:cNvSpPr/>
            <p:nvPr/>
          </p:nvSpPr>
          <p:spPr>
            <a:xfrm rot="3226368">
              <a:off x="3234187" y="2031206"/>
              <a:ext cx="1008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46" name="이등변 삼각형 45">
              <a:extLst>
                <a:ext uri="{FF2B5EF4-FFF2-40B4-BE49-F238E27FC236}">
                  <a16:creationId xmlns:a16="http://schemas.microsoft.com/office/drawing/2014/main" id="{FCE7B281-76A7-D44B-9365-1CE1DC1C66DB}"/>
                </a:ext>
              </a:extLst>
            </p:cNvPr>
            <p:cNvSpPr/>
            <p:nvPr/>
          </p:nvSpPr>
          <p:spPr>
            <a:xfrm rot="19246613">
              <a:off x="3947428" y="2749380"/>
              <a:ext cx="1008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47" name="이등변 삼각형 46">
              <a:extLst>
                <a:ext uri="{FF2B5EF4-FFF2-40B4-BE49-F238E27FC236}">
                  <a16:creationId xmlns:a16="http://schemas.microsoft.com/office/drawing/2014/main" id="{9966E07D-09DD-18A3-785E-3EE3F1576811}"/>
                </a:ext>
              </a:extLst>
            </p:cNvPr>
            <p:cNvSpPr/>
            <p:nvPr/>
          </p:nvSpPr>
          <p:spPr>
            <a:xfrm rot="3226368">
              <a:off x="3238827" y="3777132"/>
              <a:ext cx="1008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48" name="이등변 삼각형 47">
              <a:extLst>
                <a:ext uri="{FF2B5EF4-FFF2-40B4-BE49-F238E27FC236}">
                  <a16:creationId xmlns:a16="http://schemas.microsoft.com/office/drawing/2014/main" id="{D7A49D3F-AE9E-153B-04B5-547D2CAD1E02}"/>
                </a:ext>
              </a:extLst>
            </p:cNvPr>
            <p:cNvSpPr/>
            <p:nvPr/>
          </p:nvSpPr>
          <p:spPr>
            <a:xfrm rot="19246613">
              <a:off x="3952068" y="4495306"/>
              <a:ext cx="1008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49" name="이등변 삼각형 48">
              <a:extLst>
                <a:ext uri="{FF2B5EF4-FFF2-40B4-BE49-F238E27FC236}">
                  <a16:creationId xmlns:a16="http://schemas.microsoft.com/office/drawing/2014/main" id="{EFAF16BF-9B68-4F46-BEFD-6F50F6524368}"/>
                </a:ext>
              </a:extLst>
            </p:cNvPr>
            <p:cNvSpPr/>
            <p:nvPr/>
          </p:nvSpPr>
          <p:spPr>
            <a:xfrm rot="3226368">
              <a:off x="1781408" y="3773503"/>
              <a:ext cx="1008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50" name="이등변 삼각형 49">
              <a:extLst>
                <a:ext uri="{FF2B5EF4-FFF2-40B4-BE49-F238E27FC236}">
                  <a16:creationId xmlns:a16="http://schemas.microsoft.com/office/drawing/2014/main" id="{4B48F675-996A-6ECE-C5B1-11725E136A84}"/>
                </a:ext>
              </a:extLst>
            </p:cNvPr>
            <p:cNvSpPr/>
            <p:nvPr/>
          </p:nvSpPr>
          <p:spPr>
            <a:xfrm rot="19246613">
              <a:off x="2494649" y="4491677"/>
              <a:ext cx="1008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51" name="이등변 삼각형 50">
              <a:extLst>
                <a:ext uri="{FF2B5EF4-FFF2-40B4-BE49-F238E27FC236}">
                  <a16:creationId xmlns:a16="http://schemas.microsoft.com/office/drawing/2014/main" id="{6AFFC4AE-13EB-75FF-9DC9-674527EE6D07}"/>
                </a:ext>
              </a:extLst>
            </p:cNvPr>
            <p:cNvSpPr/>
            <p:nvPr/>
          </p:nvSpPr>
          <p:spPr>
            <a:xfrm rot="788308">
              <a:off x="6141755" y="2364312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52" name="이등변 삼각형 51">
              <a:extLst>
                <a:ext uri="{FF2B5EF4-FFF2-40B4-BE49-F238E27FC236}">
                  <a16:creationId xmlns:a16="http://schemas.microsoft.com/office/drawing/2014/main" id="{27898A85-DACB-D9DD-5233-FD78D08FC0FB}"/>
                </a:ext>
              </a:extLst>
            </p:cNvPr>
            <p:cNvSpPr/>
            <p:nvPr/>
          </p:nvSpPr>
          <p:spPr>
            <a:xfrm rot="11956438">
              <a:off x="7181192" y="2400008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53" name="이등변 삼각형 52">
              <a:extLst>
                <a:ext uri="{FF2B5EF4-FFF2-40B4-BE49-F238E27FC236}">
                  <a16:creationId xmlns:a16="http://schemas.microsoft.com/office/drawing/2014/main" id="{65F5ED92-F12E-468D-0D08-0ACA4DC1EA43}"/>
                </a:ext>
              </a:extLst>
            </p:cNvPr>
            <p:cNvSpPr/>
            <p:nvPr/>
          </p:nvSpPr>
          <p:spPr>
            <a:xfrm rot="11956438">
              <a:off x="6822922" y="2293595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54" name="이등변 삼각형 53">
              <a:extLst>
                <a:ext uri="{FF2B5EF4-FFF2-40B4-BE49-F238E27FC236}">
                  <a16:creationId xmlns:a16="http://schemas.microsoft.com/office/drawing/2014/main" id="{C0192C96-2B47-BDF4-8850-2F9B1382F49A}"/>
                </a:ext>
              </a:extLst>
            </p:cNvPr>
            <p:cNvSpPr/>
            <p:nvPr/>
          </p:nvSpPr>
          <p:spPr>
            <a:xfrm rot="16586482">
              <a:off x="6734544" y="2978134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55" name="이등변 삼각형 54">
              <a:extLst>
                <a:ext uri="{FF2B5EF4-FFF2-40B4-BE49-F238E27FC236}">
                  <a16:creationId xmlns:a16="http://schemas.microsoft.com/office/drawing/2014/main" id="{FDEFBDAA-0313-2BD0-88DC-E9B33F162133}"/>
                </a:ext>
              </a:extLst>
            </p:cNvPr>
            <p:cNvSpPr/>
            <p:nvPr/>
          </p:nvSpPr>
          <p:spPr>
            <a:xfrm rot="11956438">
              <a:off x="8174580" y="3926387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56" name="이등변 삼각형 55">
              <a:extLst>
                <a:ext uri="{FF2B5EF4-FFF2-40B4-BE49-F238E27FC236}">
                  <a16:creationId xmlns:a16="http://schemas.microsoft.com/office/drawing/2014/main" id="{50A3D151-E7BF-9460-EF20-1819D38AC280}"/>
                </a:ext>
              </a:extLst>
            </p:cNvPr>
            <p:cNvSpPr/>
            <p:nvPr/>
          </p:nvSpPr>
          <p:spPr>
            <a:xfrm rot="11956438">
              <a:off x="9563248" y="2176825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57" name="이등변 삼각형 56">
              <a:extLst>
                <a:ext uri="{FF2B5EF4-FFF2-40B4-BE49-F238E27FC236}">
                  <a16:creationId xmlns:a16="http://schemas.microsoft.com/office/drawing/2014/main" id="{B7C9244A-1BF1-9245-2AE6-813E07EC1132}"/>
                </a:ext>
              </a:extLst>
            </p:cNvPr>
            <p:cNvSpPr/>
            <p:nvPr/>
          </p:nvSpPr>
          <p:spPr>
            <a:xfrm rot="11956438">
              <a:off x="9563248" y="3926386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58" name="이등변 삼각형 57">
              <a:extLst>
                <a:ext uri="{FF2B5EF4-FFF2-40B4-BE49-F238E27FC236}">
                  <a16:creationId xmlns:a16="http://schemas.microsoft.com/office/drawing/2014/main" id="{B86E2E21-2344-5CA8-26F9-1EA51E58AE19}"/>
                </a:ext>
              </a:extLst>
            </p:cNvPr>
            <p:cNvSpPr/>
            <p:nvPr/>
          </p:nvSpPr>
          <p:spPr>
            <a:xfrm rot="788308">
              <a:off x="6143710" y="4105270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59" name="이등변 삼각형 58">
              <a:extLst>
                <a:ext uri="{FF2B5EF4-FFF2-40B4-BE49-F238E27FC236}">
                  <a16:creationId xmlns:a16="http://schemas.microsoft.com/office/drawing/2014/main" id="{39535451-8B4B-C1CC-E760-310BD5FAABD6}"/>
                </a:ext>
              </a:extLst>
            </p:cNvPr>
            <p:cNvSpPr/>
            <p:nvPr/>
          </p:nvSpPr>
          <p:spPr>
            <a:xfrm rot="11956438">
              <a:off x="7183147" y="4140966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60" name="이등변 삼각형 59">
              <a:extLst>
                <a:ext uri="{FF2B5EF4-FFF2-40B4-BE49-F238E27FC236}">
                  <a16:creationId xmlns:a16="http://schemas.microsoft.com/office/drawing/2014/main" id="{D553C71A-6C29-BC4E-1D0B-34BE32F9A232}"/>
                </a:ext>
              </a:extLst>
            </p:cNvPr>
            <p:cNvSpPr/>
            <p:nvPr/>
          </p:nvSpPr>
          <p:spPr>
            <a:xfrm rot="11956438">
              <a:off x="6824877" y="4034553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61" name="이등변 삼각형 60">
              <a:extLst>
                <a:ext uri="{FF2B5EF4-FFF2-40B4-BE49-F238E27FC236}">
                  <a16:creationId xmlns:a16="http://schemas.microsoft.com/office/drawing/2014/main" id="{4782BF81-B9F0-F5F1-24D2-DB47BB5FB869}"/>
                </a:ext>
              </a:extLst>
            </p:cNvPr>
            <p:cNvSpPr/>
            <p:nvPr/>
          </p:nvSpPr>
          <p:spPr>
            <a:xfrm rot="16586482">
              <a:off x="6736499" y="4719092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62" name="이등변 삼각형 61">
              <a:extLst>
                <a:ext uri="{FF2B5EF4-FFF2-40B4-BE49-F238E27FC236}">
                  <a16:creationId xmlns:a16="http://schemas.microsoft.com/office/drawing/2014/main" id="{F45A0970-F231-1C12-8658-467E207C3A67}"/>
                </a:ext>
              </a:extLst>
            </p:cNvPr>
            <p:cNvSpPr/>
            <p:nvPr/>
          </p:nvSpPr>
          <p:spPr>
            <a:xfrm rot="788308">
              <a:off x="4663275" y="4105270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63" name="이등변 삼각형 62">
              <a:extLst>
                <a:ext uri="{FF2B5EF4-FFF2-40B4-BE49-F238E27FC236}">
                  <a16:creationId xmlns:a16="http://schemas.microsoft.com/office/drawing/2014/main" id="{740B31A8-B28B-4DEA-C966-E84969CF8CF6}"/>
                </a:ext>
              </a:extLst>
            </p:cNvPr>
            <p:cNvSpPr/>
            <p:nvPr/>
          </p:nvSpPr>
          <p:spPr>
            <a:xfrm rot="11956438">
              <a:off x="5702712" y="4140966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64" name="이등변 삼각형 63">
              <a:extLst>
                <a:ext uri="{FF2B5EF4-FFF2-40B4-BE49-F238E27FC236}">
                  <a16:creationId xmlns:a16="http://schemas.microsoft.com/office/drawing/2014/main" id="{B4D496B2-BA84-5F27-14A2-8CF7F5DBC5C0}"/>
                </a:ext>
              </a:extLst>
            </p:cNvPr>
            <p:cNvSpPr/>
            <p:nvPr/>
          </p:nvSpPr>
          <p:spPr>
            <a:xfrm rot="11956438">
              <a:off x="5344442" y="4034553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  <p:sp>
          <p:nvSpPr>
            <p:cNvPr id="65" name="이등변 삼각형 64">
              <a:extLst>
                <a:ext uri="{FF2B5EF4-FFF2-40B4-BE49-F238E27FC236}">
                  <a16:creationId xmlns:a16="http://schemas.microsoft.com/office/drawing/2014/main" id="{687683D6-BAC4-F517-81A3-CFA9171B3921}"/>
                </a:ext>
              </a:extLst>
            </p:cNvPr>
            <p:cNvSpPr/>
            <p:nvPr/>
          </p:nvSpPr>
          <p:spPr>
            <a:xfrm rot="16586482">
              <a:off x="5256064" y="4719092"/>
              <a:ext cx="104400" cy="324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" rtlCol="0" anchor="ctr" anchorCtr="0"/>
            <a:lstStyle/>
            <a:p>
              <a:pPr algn="ctr"/>
              <a:endParaRPr lang="ko-KR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7571497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그림 20">
            <a:extLst>
              <a:ext uri="{FF2B5EF4-FFF2-40B4-BE49-F238E27FC236}">
                <a16:creationId xmlns:a16="http://schemas.microsoft.com/office/drawing/2014/main" id="{88D217F3-14C9-973D-EA9D-3927367CF8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A866B8EE-48AA-2F24-5E3A-E862A11A3E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2FDA609C-9EBF-CA18-57A2-01640E11D7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23" name="그림 22">
            <a:extLst>
              <a:ext uri="{FF2B5EF4-FFF2-40B4-BE49-F238E27FC236}">
                <a16:creationId xmlns:a16="http://schemas.microsoft.com/office/drawing/2014/main" id="{63F53FBC-39F6-A1F0-1EC8-72F8802CA29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4481CD4D-FDA0-C124-1B47-5867A8954816}"/>
              </a:ext>
            </a:extLst>
          </p:cNvPr>
          <p:cNvSpPr/>
          <p:nvPr/>
        </p:nvSpPr>
        <p:spPr>
          <a:xfrm>
            <a:off x="3015674" y="1088329"/>
            <a:ext cx="5040000" cy="504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8D581134-16EB-0D78-A14B-14766C98C423}"/>
              </a:ext>
            </a:extLst>
          </p:cNvPr>
          <p:cNvCxnSpPr/>
          <p:nvPr/>
        </p:nvCxnSpPr>
        <p:spPr>
          <a:xfrm>
            <a:off x="2844798" y="6493164"/>
            <a:ext cx="104400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215002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그림 11">
            <a:extLst>
              <a:ext uri="{FF2B5EF4-FFF2-40B4-BE49-F238E27FC236}">
                <a16:creationId xmlns:a16="http://schemas.microsoft.com/office/drawing/2014/main" id="{823EC5D6-A69E-7F48-5B42-C034DBD2E0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294CC157-60C9-5BA8-ECBD-5C00596AB0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8CB2712F-BAA8-AF4B-B3BB-4AE874DF97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B0DA1E28-2018-0CCC-6794-EA1FE8C52B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4481CD4D-FDA0-C124-1B47-5867A8954816}"/>
              </a:ext>
            </a:extLst>
          </p:cNvPr>
          <p:cNvSpPr/>
          <p:nvPr/>
        </p:nvSpPr>
        <p:spPr>
          <a:xfrm>
            <a:off x="3339524" y="583504"/>
            <a:ext cx="5040000" cy="504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000111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그림 12">
            <a:extLst>
              <a:ext uri="{FF2B5EF4-FFF2-40B4-BE49-F238E27FC236}">
                <a16:creationId xmlns:a16="http://schemas.microsoft.com/office/drawing/2014/main" id="{376262F8-78C9-272E-6487-3C9633BB65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521FACBB-E459-403D-5F27-4B96E5F202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FA344A11-192C-D7EC-0A9D-C29D64945BC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DF75176F-742B-9F45-401A-8B4241BC32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4481CD4D-FDA0-C124-1B47-5867A8954816}"/>
              </a:ext>
            </a:extLst>
          </p:cNvPr>
          <p:cNvSpPr/>
          <p:nvPr/>
        </p:nvSpPr>
        <p:spPr>
          <a:xfrm>
            <a:off x="4158674" y="1440754"/>
            <a:ext cx="5040000" cy="504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660266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2</TotalTime>
  <Words>38</Words>
  <Application>Microsoft Office PowerPoint</Application>
  <PresentationFormat>와이드스크린</PresentationFormat>
  <Paragraphs>15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25</cp:revision>
  <dcterms:created xsi:type="dcterms:W3CDTF">2023-12-13T07:27:58Z</dcterms:created>
  <dcterms:modified xsi:type="dcterms:W3CDTF">2024-09-30T05:56:56Z</dcterms:modified>
</cp:coreProperties>
</file>